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5FD326-7B16-45DF-ABAC-6E804BA14A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D10B3-34D9-4D27-A71E-8BE72BDCA5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ED8B4-A722-4F93-A362-1EB17A8BED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790BA-D0F9-4E55-9BE1-0135912E14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67E7F-C63D-45A6-95D3-F93D82AF3B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42D68-6C10-46E5-996E-F5058033DF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3DAED-C2C2-46A9-BA26-A326AD5291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15337-D71F-496A-956E-CD718B79E0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FDBEE3-9CB1-47EA-B7B6-4575F77445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528B57-C13D-4ECF-AC6D-3139AB39FC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20314-4C48-44D6-BFE7-A5472043E9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AFA03-5DD7-44D3-8600-888AA8D37A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5D64A6-6090-41AE-97B2-A6600AAFF72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95120" y="2201760"/>
            <a:ext cx="1193760" cy="307080"/>
            <a:chOff x="195120" y="2201760"/>
            <a:chExt cx="1193760" cy="307080"/>
          </a:xfrm>
        </p:grpSpPr>
        <p:sp>
          <p:nvSpPr>
            <p:cNvPr id="42" name=""/>
            <p:cNvSpPr/>
            <p:nvPr/>
          </p:nvSpPr>
          <p:spPr>
            <a:xfrm>
              <a:off x="855360" y="2354040"/>
              <a:ext cx="533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95120" y="2201760"/>
              <a:ext cx="863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ND2.B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"/>
          <p:cNvGrpSpPr/>
          <p:nvPr/>
        </p:nvGrpSpPr>
        <p:grpSpPr>
          <a:xfrm>
            <a:off x="6819840" y="2208240"/>
            <a:ext cx="1739520" cy="307080"/>
            <a:chOff x="6819840" y="2208240"/>
            <a:chExt cx="1739520" cy="307080"/>
          </a:xfrm>
        </p:grpSpPr>
        <p:sp>
          <p:nvSpPr>
            <p:cNvPr id="45" name=""/>
            <p:cNvSpPr/>
            <p:nvPr/>
          </p:nvSpPr>
          <p:spPr>
            <a:xfrm>
              <a:off x="7432560" y="2208240"/>
              <a:ext cx="1126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ND2.EGila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flipH="1">
              <a:off x="6819840" y="2360520"/>
              <a:ext cx="662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7" name=""/>
          <p:cNvSpPr/>
          <p:nvPr/>
        </p:nvSpPr>
        <p:spPr>
          <a:xfrm>
            <a:off x="1803240" y="433440"/>
            <a:ext cx="5537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ND1-2 regio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417840" y="1568520"/>
            <a:ext cx="1327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ND1 975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333440" y="1495440"/>
            <a:ext cx="5603760" cy="6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"/>
          <p:cNvGrpSpPr/>
          <p:nvPr/>
        </p:nvGrpSpPr>
        <p:grpSpPr>
          <a:xfrm>
            <a:off x="5460840" y="1352520"/>
            <a:ext cx="1097280" cy="382680"/>
            <a:chOff x="5460840" y="1352520"/>
            <a:chExt cx="1097280" cy="382680"/>
          </a:xfrm>
        </p:grpSpPr>
        <p:sp>
          <p:nvSpPr>
            <p:cNvPr id="51" name=""/>
            <p:cNvSpPr/>
            <p:nvPr/>
          </p:nvSpPr>
          <p:spPr>
            <a:xfrm>
              <a:off x="5460840" y="1352520"/>
              <a:ext cx="109728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670720" y="1366920"/>
              <a:ext cx="677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IL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"/>
          <p:cNvGrpSpPr/>
          <p:nvPr/>
        </p:nvGrpSpPr>
        <p:grpSpPr>
          <a:xfrm>
            <a:off x="6562800" y="1352520"/>
            <a:ext cx="1096920" cy="382320"/>
            <a:chOff x="6562800" y="1352520"/>
            <a:chExt cx="1096920" cy="382320"/>
          </a:xfrm>
        </p:grpSpPr>
        <p:sp>
          <p:nvSpPr>
            <p:cNvPr id="54" name=""/>
            <p:cNvSpPr/>
            <p:nvPr/>
          </p:nvSpPr>
          <p:spPr>
            <a:xfrm>
              <a:off x="6562800" y="1352520"/>
              <a:ext cx="1096920" cy="304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772320" y="1366560"/>
              <a:ext cx="677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"/>
          <p:cNvGrpSpPr/>
          <p:nvPr/>
        </p:nvGrpSpPr>
        <p:grpSpPr>
          <a:xfrm>
            <a:off x="7661160" y="1352520"/>
            <a:ext cx="1096920" cy="382680"/>
            <a:chOff x="7661160" y="1352520"/>
            <a:chExt cx="1096920" cy="382680"/>
          </a:xfrm>
        </p:grpSpPr>
        <p:sp>
          <p:nvSpPr>
            <p:cNvPr id="57" name=""/>
            <p:cNvSpPr/>
            <p:nvPr/>
          </p:nvSpPr>
          <p:spPr>
            <a:xfrm>
              <a:off x="7661160" y="135252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7869960" y="136692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MET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"/>
          <p:cNvGrpSpPr/>
          <p:nvPr/>
        </p:nvGrpSpPr>
        <p:grpSpPr>
          <a:xfrm>
            <a:off x="5643360" y="925560"/>
            <a:ext cx="1333800" cy="307080"/>
            <a:chOff x="5643360" y="925560"/>
            <a:chExt cx="1333800" cy="307080"/>
          </a:xfrm>
        </p:grpSpPr>
        <p:sp>
          <p:nvSpPr>
            <p:cNvPr id="60" name=""/>
            <p:cNvSpPr/>
            <p:nvPr/>
          </p:nvSpPr>
          <p:spPr>
            <a:xfrm>
              <a:off x="6113520" y="92556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Ile24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H="1">
              <a:off x="5643360" y="1077840"/>
              <a:ext cx="507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" name=""/>
          <p:cNvSpPr/>
          <p:nvPr/>
        </p:nvSpPr>
        <p:spPr>
          <a:xfrm>
            <a:off x="3666960" y="2793960"/>
            <a:ext cx="142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ND2 1050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72960" y="3484440"/>
            <a:ext cx="8458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st reaction, each primer pair, anneal at 48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o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, 35 cycles, 75 secs exten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"/>
          <p:cNvGrpSpPr/>
          <p:nvPr/>
        </p:nvGrpSpPr>
        <p:grpSpPr>
          <a:xfrm>
            <a:off x="6562800" y="1352520"/>
            <a:ext cx="1096920" cy="382320"/>
            <a:chOff x="6562800" y="1352520"/>
            <a:chExt cx="1096920" cy="382320"/>
          </a:xfrm>
        </p:grpSpPr>
        <p:sp>
          <p:nvSpPr>
            <p:cNvPr id="65" name=""/>
            <p:cNvSpPr/>
            <p:nvPr/>
          </p:nvSpPr>
          <p:spPr>
            <a:xfrm>
              <a:off x="6562800" y="1352520"/>
              <a:ext cx="1096920" cy="304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772320" y="1366560"/>
              <a:ext cx="677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GL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"/>
          <p:cNvGrpSpPr/>
          <p:nvPr/>
        </p:nvGrpSpPr>
        <p:grpSpPr>
          <a:xfrm>
            <a:off x="453960" y="1365120"/>
            <a:ext cx="2212560" cy="382680"/>
            <a:chOff x="453960" y="1365120"/>
            <a:chExt cx="2212560" cy="382680"/>
          </a:xfrm>
        </p:grpSpPr>
        <p:sp>
          <p:nvSpPr>
            <p:cNvPr id="68" name=""/>
            <p:cNvSpPr/>
            <p:nvPr/>
          </p:nvSpPr>
          <p:spPr>
            <a:xfrm>
              <a:off x="1569600" y="136512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779480" y="1379520"/>
              <a:ext cx="779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LEU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0" name=""/>
            <p:cNvGrpSpPr/>
            <p:nvPr/>
          </p:nvGrpSpPr>
          <p:grpSpPr>
            <a:xfrm>
              <a:off x="453960" y="1365120"/>
              <a:ext cx="1096920" cy="382680"/>
              <a:chOff x="453960" y="1365120"/>
              <a:chExt cx="1096920" cy="382680"/>
            </a:xfrm>
          </p:grpSpPr>
          <p:sp>
            <p:nvSpPr>
              <p:cNvPr id="71" name=""/>
              <p:cNvSpPr/>
              <p:nvPr/>
            </p:nvSpPr>
            <p:spPr>
              <a:xfrm>
                <a:off x="453960" y="1365120"/>
                <a:ext cx="1096920" cy="304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663480" y="1379520"/>
                <a:ext cx="67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16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73" name=""/>
          <p:cNvSpPr/>
          <p:nvPr/>
        </p:nvSpPr>
        <p:spPr>
          <a:xfrm flipV="1">
            <a:off x="1492200" y="2707920"/>
            <a:ext cx="639612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"/>
          <p:cNvGrpSpPr/>
          <p:nvPr/>
        </p:nvGrpSpPr>
        <p:grpSpPr>
          <a:xfrm>
            <a:off x="479520" y="2562120"/>
            <a:ext cx="1096920" cy="382680"/>
            <a:chOff x="479520" y="2562120"/>
            <a:chExt cx="1096920" cy="382680"/>
          </a:xfrm>
        </p:grpSpPr>
        <p:sp>
          <p:nvSpPr>
            <p:cNvPr id="75" name=""/>
            <p:cNvSpPr/>
            <p:nvPr/>
          </p:nvSpPr>
          <p:spPr>
            <a:xfrm>
              <a:off x="479520" y="256212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88320" y="257652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LEU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"/>
          <p:cNvGrpSpPr/>
          <p:nvPr/>
        </p:nvGrpSpPr>
        <p:grpSpPr>
          <a:xfrm>
            <a:off x="7742160" y="2571840"/>
            <a:ext cx="1096920" cy="382680"/>
            <a:chOff x="7742160" y="2571840"/>
            <a:chExt cx="1096920" cy="382680"/>
          </a:xfrm>
        </p:grpSpPr>
        <p:sp>
          <p:nvSpPr>
            <p:cNvPr id="78" name=""/>
            <p:cNvSpPr/>
            <p:nvPr/>
          </p:nvSpPr>
          <p:spPr>
            <a:xfrm>
              <a:off x="7742160" y="257184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7950960" y="258624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GLU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"/>
          <p:cNvSpPr/>
          <p:nvPr/>
        </p:nvSpPr>
        <p:spPr>
          <a:xfrm flipV="1">
            <a:off x="1492200" y="2707920"/>
            <a:ext cx="639612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1" name=""/>
          <p:cNvGrpSpPr/>
          <p:nvPr/>
        </p:nvGrpSpPr>
        <p:grpSpPr>
          <a:xfrm>
            <a:off x="479520" y="2562120"/>
            <a:ext cx="1096920" cy="382680"/>
            <a:chOff x="479520" y="2562120"/>
            <a:chExt cx="1096920" cy="382680"/>
          </a:xfrm>
        </p:grpSpPr>
        <p:sp>
          <p:nvSpPr>
            <p:cNvPr id="82" name=""/>
            <p:cNvSpPr/>
            <p:nvPr/>
          </p:nvSpPr>
          <p:spPr>
            <a:xfrm>
              <a:off x="479520" y="256212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688320" y="257652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GL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"/>
          <p:cNvGrpSpPr/>
          <p:nvPr/>
        </p:nvGrpSpPr>
        <p:grpSpPr>
          <a:xfrm>
            <a:off x="7742160" y="2571840"/>
            <a:ext cx="1096920" cy="382680"/>
            <a:chOff x="7742160" y="2571840"/>
            <a:chExt cx="1096920" cy="382680"/>
          </a:xfrm>
        </p:grpSpPr>
        <p:sp>
          <p:nvSpPr>
            <p:cNvPr id="85" name=""/>
            <p:cNvSpPr/>
            <p:nvPr/>
          </p:nvSpPr>
          <p:spPr>
            <a:xfrm>
              <a:off x="7742160" y="257184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950960" y="258624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L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" name=""/>
          <p:cNvGrpSpPr/>
          <p:nvPr/>
        </p:nvGrpSpPr>
        <p:grpSpPr>
          <a:xfrm>
            <a:off x="7742160" y="2571840"/>
            <a:ext cx="1096920" cy="382680"/>
            <a:chOff x="7742160" y="2571840"/>
            <a:chExt cx="1096920" cy="382680"/>
          </a:xfrm>
        </p:grpSpPr>
        <p:sp>
          <p:nvSpPr>
            <p:cNvPr id="88" name=""/>
            <p:cNvSpPr/>
            <p:nvPr/>
          </p:nvSpPr>
          <p:spPr>
            <a:xfrm>
              <a:off x="7742160" y="257184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7950960" y="258624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L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" name=""/>
          <p:cNvGrpSpPr/>
          <p:nvPr/>
        </p:nvGrpSpPr>
        <p:grpSpPr>
          <a:xfrm>
            <a:off x="7742160" y="2571840"/>
            <a:ext cx="1096920" cy="382680"/>
            <a:chOff x="7742160" y="2571840"/>
            <a:chExt cx="1096920" cy="382680"/>
          </a:xfrm>
        </p:grpSpPr>
        <p:sp>
          <p:nvSpPr>
            <p:cNvPr id="91" name=""/>
            <p:cNvSpPr/>
            <p:nvPr/>
          </p:nvSpPr>
          <p:spPr>
            <a:xfrm>
              <a:off x="7742160" y="257184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7950960" y="258624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L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3" name=""/>
          <p:cNvGrpSpPr/>
          <p:nvPr/>
        </p:nvGrpSpPr>
        <p:grpSpPr>
          <a:xfrm>
            <a:off x="7742160" y="2571840"/>
            <a:ext cx="1096920" cy="382680"/>
            <a:chOff x="7742160" y="2571840"/>
            <a:chExt cx="1096920" cy="382680"/>
          </a:xfrm>
        </p:grpSpPr>
        <p:sp>
          <p:nvSpPr>
            <p:cNvPr id="94" name=""/>
            <p:cNvSpPr/>
            <p:nvPr/>
          </p:nvSpPr>
          <p:spPr>
            <a:xfrm>
              <a:off x="7742160" y="257184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7950960" y="258624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L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"/>
          <p:cNvGrpSpPr/>
          <p:nvPr/>
        </p:nvGrpSpPr>
        <p:grpSpPr>
          <a:xfrm>
            <a:off x="6637320" y="2571840"/>
            <a:ext cx="1096920" cy="382680"/>
            <a:chOff x="6637320" y="2571840"/>
            <a:chExt cx="1096920" cy="382680"/>
          </a:xfrm>
        </p:grpSpPr>
        <p:sp>
          <p:nvSpPr>
            <p:cNvPr id="97" name=""/>
            <p:cNvSpPr/>
            <p:nvPr/>
          </p:nvSpPr>
          <p:spPr>
            <a:xfrm>
              <a:off x="6637320" y="257184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6846120" y="258624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TRP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" name=""/>
          <p:cNvGrpSpPr/>
          <p:nvPr/>
        </p:nvGrpSpPr>
        <p:grpSpPr>
          <a:xfrm>
            <a:off x="1582560" y="2558880"/>
            <a:ext cx="1097280" cy="382680"/>
            <a:chOff x="1582560" y="2558880"/>
            <a:chExt cx="1097280" cy="382680"/>
          </a:xfrm>
        </p:grpSpPr>
        <p:sp>
          <p:nvSpPr>
            <p:cNvPr id="100" name=""/>
            <p:cNvSpPr/>
            <p:nvPr/>
          </p:nvSpPr>
          <p:spPr>
            <a:xfrm>
              <a:off x="1582560" y="2558880"/>
              <a:ext cx="109728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791360" y="2573280"/>
              <a:ext cx="67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MET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2" name=""/>
          <p:cNvSpPr/>
          <p:nvPr/>
        </p:nvSpPr>
        <p:spPr>
          <a:xfrm>
            <a:off x="2222640" y="1079640"/>
            <a:ext cx="355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486080" y="927000"/>
            <a:ext cx="86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Lue3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0" y="4317840"/>
            <a:ext cx="9144000" cy="160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rime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eu3F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AAGGTGGCAGAGCATGGTA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le24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TCTATCAAAGTGGTCCTTG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D2.B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TCCTGGTGCTTCCTCTA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D2.EgilaF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TGCTTAGAGCTTTGAAGG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0" y="0"/>
            <a:ext cx="8763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. All primers used to generate catostomid sequenc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"/>
          <p:cNvSpPr/>
          <p:nvPr/>
        </p:nvSpPr>
        <p:spPr>
          <a:xfrm>
            <a:off x="2070000" y="1587600"/>
            <a:ext cx="6527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457200" y="1447920"/>
            <a:ext cx="1600200" cy="304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838080" y="141912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58840" y="2525760"/>
            <a:ext cx="8885160" cy="162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ys.22F and CO3.Cato.23R, anneal at 48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o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, 35 cycles, 75 secs exten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ime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ys.22F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AAGCGTTAGCCTTTTAAG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3.Cato.23R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GCTTGGATCAACCATATGA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0" name=""/>
          <p:cNvGrpSpPr/>
          <p:nvPr/>
        </p:nvGrpSpPr>
        <p:grpSpPr>
          <a:xfrm>
            <a:off x="0" y="1011240"/>
            <a:ext cx="1442520" cy="307080"/>
            <a:chOff x="0" y="1011240"/>
            <a:chExt cx="1442520" cy="307080"/>
          </a:xfrm>
        </p:grpSpPr>
        <p:sp>
          <p:nvSpPr>
            <p:cNvPr id="111" name=""/>
            <p:cNvSpPr/>
            <p:nvPr/>
          </p:nvSpPr>
          <p:spPr>
            <a:xfrm>
              <a:off x="745920" y="1163520"/>
              <a:ext cx="696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0" y="1011240"/>
              <a:ext cx="82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Lys.22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3" name=""/>
          <p:cNvGrpSpPr/>
          <p:nvPr/>
        </p:nvGrpSpPr>
        <p:grpSpPr>
          <a:xfrm>
            <a:off x="7238520" y="977760"/>
            <a:ext cx="1955880" cy="307080"/>
            <a:chOff x="7238520" y="977760"/>
            <a:chExt cx="1955880" cy="307080"/>
          </a:xfrm>
        </p:grpSpPr>
        <p:sp>
          <p:nvSpPr>
            <p:cNvPr id="114" name=""/>
            <p:cNvSpPr/>
            <p:nvPr/>
          </p:nvSpPr>
          <p:spPr>
            <a:xfrm>
              <a:off x="7927920" y="977760"/>
              <a:ext cx="1266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CO3.Cato.23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H="1">
              <a:off x="7238520" y="1130040"/>
              <a:ext cx="74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6" name=""/>
          <p:cNvSpPr/>
          <p:nvPr/>
        </p:nvSpPr>
        <p:spPr>
          <a:xfrm>
            <a:off x="3138480" y="131760"/>
            <a:ext cx="2865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TPase 6/8, 841 b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7124760" y="1434960"/>
            <a:ext cx="0" cy="279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886200" y="1447920"/>
            <a:ext cx="0" cy="27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235240" y="1635120"/>
            <a:ext cx="120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TPase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4940280" y="1635120"/>
            <a:ext cx="120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TPase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7620120" y="1635120"/>
            <a:ext cx="120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II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400480" y="1168560"/>
            <a:ext cx="4089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69 bp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83 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809880" y="1447920"/>
            <a:ext cx="0" cy="27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"/>
          <p:cNvSpPr/>
          <p:nvPr/>
        </p:nvSpPr>
        <p:spPr>
          <a:xfrm>
            <a:off x="1803240" y="166680"/>
            <a:ext cx="5537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ND4-6 region, cyt</a:t>
            </a:r>
            <a:r>
              <a:rPr b="1" i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51000" y="4130640"/>
            <a:ext cx="8366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te that both gene pairs, ND4L &amp; ND4 and ND5 &amp; ND6 overlap with each other a few base pairs.  The reading frame for ND6 is in reverse too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09600" y="4894200"/>
            <a:ext cx="8585280" cy="147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st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reaction, Cato.Arg.1F-Cat.Glu.R, anneal at 55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o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, 35 cycles, 4 min extension (or to include cyt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oo, Cato.Arg.1F-Cato.15990, 6 min extensio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ilute 1:49, then use 1ul in 2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nd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reac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nd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reaction, each primer pair, anneal at 48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o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, 35 cycles, 60 secs exten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665360" y="1479600"/>
            <a:ext cx="374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ND4L 297 bp                   ND4    1380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359000" y="1482840"/>
            <a:ext cx="5603760" cy="6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457200" y="1352520"/>
            <a:ext cx="1096920" cy="304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0" name=""/>
          <p:cNvGrpSpPr/>
          <p:nvPr/>
        </p:nvGrpSpPr>
        <p:grpSpPr>
          <a:xfrm>
            <a:off x="5448240" y="1352520"/>
            <a:ext cx="1096920" cy="382680"/>
            <a:chOff x="5448240" y="1352520"/>
            <a:chExt cx="1096920" cy="382680"/>
          </a:xfrm>
        </p:grpSpPr>
        <p:sp>
          <p:nvSpPr>
            <p:cNvPr id="131" name=""/>
            <p:cNvSpPr/>
            <p:nvPr/>
          </p:nvSpPr>
          <p:spPr>
            <a:xfrm>
              <a:off x="5448240" y="135252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5658120" y="1366920"/>
              <a:ext cx="676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HI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3" name=""/>
          <p:cNvSpPr/>
          <p:nvPr/>
        </p:nvSpPr>
        <p:spPr>
          <a:xfrm>
            <a:off x="666720" y="135252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R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4" name=""/>
          <p:cNvGrpSpPr/>
          <p:nvPr/>
        </p:nvGrpSpPr>
        <p:grpSpPr>
          <a:xfrm>
            <a:off x="6562800" y="1352520"/>
            <a:ext cx="1096920" cy="382320"/>
            <a:chOff x="6562800" y="1352520"/>
            <a:chExt cx="1096920" cy="382320"/>
          </a:xfrm>
        </p:grpSpPr>
        <p:sp>
          <p:nvSpPr>
            <p:cNvPr id="135" name=""/>
            <p:cNvSpPr/>
            <p:nvPr/>
          </p:nvSpPr>
          <p:spPr>
            <a:xfrm>
              <a:off x="6562800" y="1352520"/>
              <a:ext cx="1096920" cy="304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6772320" y="1366560"/>
              <a:ext cx="677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7" name=""/>
          <p:cNvGrpSpPr/>
          <p:nvPr/>
        </p:nvGrpSpPr>
        <p:grpSpPr>
          <a:xfrm>
            <a:off x="7661160" y="1352520"/>
            <a:ext cx="1096920" cy="382680"/>
            <a:chOff x="7661160" y="1352520"/>
            <a:chExt cx="1096920" cy="382680"/>
          </a:xfrm>
        </p:grpSpPr>
        <p:sp>
          <p:nvSpPr>
            <p:cNvPr id="138" name=""/>
            <p:cNvSpPr/>
            <p:nvPr/>
          </p:nvSpPr>
          <p:spPr>
            <a:xfrm>
              <a:off x="7661160" y="135252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7869960" y="136692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LEU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0" name=""/>
          <p:cNvSpPr/>
          <p:nvPr/>
        </p:nvSpPr>
        <p:spPr>
          <a:xfrm>
            <a:off x="2936880" y="1324080"/>
            <a:ext cx="0" cy="3762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1" name=""/>
          <p:cNvGrpSpPr/>
          <p:nvPr/>
        </p:nvGrpSpPr>
        <p:grpSpPr>
          <a:xfrm>
            <a:off x="5796000" y="658800"/>
            <a:ext cx="1536480" cy="307080"/>
            <a:chOff x="5796000" y="658800"/>
            <a:chExt cx="1536480" cy="307080"/>
          </a:xfrm>
        </p:grpSpPr>
        <p:sp>
          <p:nvSpPr>
            <p:cNvPr id="142" name=""/>
            <p:cNvSpPr/>
            <p:nvPr/>
          </p:nvSpPr>
          <p:spPr>
            <a:xfrm>
              <a:off x="6337440" y="658800"/>
              <a:ext cx="995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Cato.His.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H="1">
              <a:off x="5796000" y="811080"/>
              <a:ext cx="585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4" name=""/>
          <p:cNvGrpSpPr/>
          <p:nvPr/>
        </p:nvGrpSpPr>
        <p:grpSpPr>
          <a:xfrm>
            <a:off x="304920" y="927000"/>
            <a:ext cx="1193760" cy="307080"/>
            <a:chOff x="304920" y="927000"/>
            <a:chExt cx="1193760" cy="307080"/>
          </a:xfrm>
        </p:grpSpPr>
        <p:sp>
          <p:nvSpPr>
            <p:cNvPr id="145" name=""/>
            <p:cNvSpPr/>
            <p:nvPr/>
          </p:nvSpPr>
          <p:spPr>
            <a:xfrm>
              <a:off x="965160" y="1079280"/>
              <a:ext cx="533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304920" y="927000"/>
              <a:ext cx="863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Arg.2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7" name=""/>
          <p:cNvGrpSpPr/>
          <p:nvPr/>
        </p:nvGrpSpPr>
        <p:grpSpPr>
          <a:xfrm>
            <a:off x="2430360" y="658800"/>
            <a:ext cx="1193760" cy="307080"/>
            <a:chOff x="2430360" y="658800"/>
            <a:chExt cx="1193760" cy="307080"/>
          </a:xfrm>
        </p:grpSpPr>
        <p:sp>
          <p:nvSpPr>
            <p:cNvPr id="148" name=""/>
            <p:cNvSpPr/>
            <p:nvPr/>
          </p:nvSpPr>
          <p:spPr>
            <a:xfrm>
              <a:off x="3171960" y="811080"/>
              <a:ext cx="452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430360" y="65880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4.369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0" name=""/>
          <p:cNvGrpSpPr/>
          <p:nvPr/>
        </p:nvGrpSpPr>
        <p:grpSpPr>
          <a:xfrm>
            <a:off x="3928680" y="993600"/>
            <a:ext cx="1333800" cy="307080"/>
            <a:chOff x="3928680" y="993600"/>
            <a:chExt cx="1333800" cy="307080"/>
          </a:xfrm>
        </p:grpSpPr>
        <p:sp>
          <p:nvSpPr>
            <p:cNvPr id="151" name=""/>
            <p:cNvSpPr/>
            <p:nvPr/>
          </p:nvSpPr>
          <p:spPr>
            <a:xfrm>
              <a:off x="4398840" y="99360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4.598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H="1">
              <a:off x="3928680" y="1145880"/>
              <a:ext cx="507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3" name=""/>
          <p:cNvSpPr/>
          <p:nvPr/>
        </p:nvSpPr>
        <p:spPr>
          <a:xfrm>
            <a:off x="3184560" y="2705040"/>
            <a:ext cx="4684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ND5 1827 bp                                                  ND6  519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1504800" y="3559320"/>
            <a:ext cx="639612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5" name=""/>
          <p:cNvGrpSpPr/>
          <p:nvPr/>
        </p:nvGrpSpPr>
        <p:grpSpPr>
          <a:xfrm>
            <a:off x="492120" y="3413160"/>
            <a:ext cx="1096920" cy="382680"/>
            <a:chOff x="492120" y="3413160"/>
            <a:chExt cx="1096920" cy="382680"/>
          </a:xfrm>
        </p:grpSpPr>
        <p:sp>
          <p:nvSpPr>
            <p:cNvPr id="156" name=""/>
            <p:cNvSpPr/>
            <p:nvPr/>
          </p:nvSpPr>
          <p:spPr>
            <a:xfrm>
              <a:off x="492120" y="3413160"/>
              <a:ext cx="109692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700920" y="3427560"/>
              <a:ext cx="67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GLU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8" name=""/>
          <p:cNvSpPr/>
          <p:nvPr/>
        </p:nvSpPr>
        <p:spPr>
          <a:xfrm>
            <a:off x="7754760" y="3422520"/>
            <a:ext cx="1097280" cy="3049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7964640" y="3436920"/>
            <a:ext cx="77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0" name=""/>
          <p:cNvGrpSpPr/>
          <p:nvPr/>
        </p:nvGrpSpPr>
        <p:grpSpPr>
          <a:xfrm>
            <a:off x="6562800" y="1352520"/>
            <a:ext cx="1096920" cy="382320"/>
            <a:chOff x="6562800" y="1352520"/>
            <a:chExt cx="1096920" cy="382320"/>
          </a:xfrm>
        </p:grpSpPr>
        <p:sp>
          <p:nvSpPr>
            <p:cNvPr id="161" name=""/>
            <p:cNvSpPr/>
            <p:nvPr/>
          </p:nvSpPr>
          <p:spPr>
            <a:xfrm>
              <a:off x="6562800" y="1352520"/>
              <a:ext cx="1096920" cy="304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6772320" y="1366560"/>
              <a:ext cx="677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3" name=""/>
          <p:cNvGrpSpPr/>
          <p:nvPr/>
        </p:nvGrpSpPr>
        <p:grpSpPr>
          <a:xfrm>
            <a:off x="6638760" y="3422520"/>
            <a:ext cx="1097280" cy="382680"/>
            <a:chOff x="6638760" y="3422520"/>
            <a:chExt cx="1097280" cy="382680"/>
          </a:xfrm>
        </p:grpSpPr>
        <p:sp>
          <p:nvSpPr>
            <p:cNvPr id="164" name=""/>
            <p:cNvSpPr/>
            <p:nvPr/>
          </p:nvSpPr>
          <p:spPr>
            <a:xfrm>
              <a:off x="6638760" y="3422520"/>
              <a:ext cx="1097280" cy="304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6848280" y="3436920"/>
              <a:ext cx="677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TH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6" name=""/>
          <p:cNvGrpSpPr/>
          <p:nvPr/>
        </p:nvGrpSpPr>
        <p:grpSpPr>
          <a:xfrm>
            <a:off x="479520" y="2535120"/>
            <a:ext cx="8359560" cy="419400"/>
            <a:chOff x="479520" y="2535120"/>
            <a:chExt cx="8359560" cy="419400"/>
          </a:xfrm>
        </p:grpSpPr>
        <p:sp>
          <p:nvSpPr>
            <p:cNvPr id="167" name=""/>
            <p:cNvSpPr/>
            <p:nvPr/>
          </p:nvSpPr>
          <p:spPr>
            <a:xfrm flipV="1">
              <a:off x="1492200" y="2707920"/>
              <a:ext cx="639612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8" name=""/>
            <p:cNvGrpSpPr/>
            <p:nvPr/>
          </p:nvGrpSpPr>
          <p:grpSpPr>
            <a:xfrm>
              <a:off x="479520" y="2562120"/>
              <a:ext cx="1096920" cy="382680"/>
              <a:chOff x="479520" y="2562120"/>
              <a:chExt cx="1096920" cy="382680"/>
            </a:xfrm>
          </p:grpSpPr>
          <p:sp>
            <p:nvSpPr>
              <p:cNvPr id="169" name=""/>
              <p:cNvSpPr/>
              <p:nvPr/>
            </p:nvSpPr>
            <p:spPr>
              <a:xfrm>
                <a:off x="479520" y="2562120"/>
                <a:ext cx="1096920" cy="304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688320" y="2576520"/>
                <a:ext cx="6786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LEU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1" name=""/>
            <p:cNvGrpSpPr/>
            <p:nvPr/>
          </p:nvGrpSpPr>
          <p:grpSpPr>
            <a:xfrm>
              <a:off x="7742160" y="2571840"/>
              <a:ext cx="1096920" cy="382680"/>
              <a:chOff x="7742160" y="2571840"/>
              <a:chExt cx="1096920" cy="382680"/>
            </a:xfrm>
          </p:grpSpPr>
          <p:sp>
            <p:nvSpPr>
              <p:cNvPr id="172" name=""/>
              <p:cNvSpPr/>
              <p:nvPr/>
            </p:nvSpPr>
            <p:spPr>
              <a:xfrm>
                <a:off x="7742160" y="2571840"/>
                <a:ext cx="1096920" cy="304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7950960" y="2586240"/>
                <a:ext cx="6786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GLU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4" name=""/>
            <p:cNvSpPr/>
            <p:nvPr/>
          </p:nvSpPr>
          <p:spPr>
            <a:xfrm>
              <a:off x="6086520" y="2535120"/>
              <a:ext cx="0" cy="3351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5" name=""/>
          <p:cNvGrpSpPr/>
          <p:nvPr/>
        </p:nvGrpSpPr>
        <p:grpSpPr>
          <a:xfrm>
            <a:off x="479520" y="2535120"/>
            <a:ext cx="8359560" cy="419400"/>
            <a:chOff x="479520" y="2535120"/>
            <a:chExt cx="8359560" cy="419400"/>
          </a:xfrm>
        </p:grpSpPr>
        <p:sp>
          <p:nvSpPr>
            <p:cNvPr id="176" name=""/>
            <p:cNvSpPr/>
            <p:nvPr/>
          </p:nvSpPr>
          <p:spPr>
            <a:xfrm flipV="1">
              <a:off x="1492200" y="2707920"/>
              <a:ext cx="639612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7" name=""/>
            <p:cNvGrpSpPr/>
            <p:nvPr/>
          </p:nvGrpSpPr>
          <p:grpSpPr>
            <a:xfrm>
              <a:off x="479520" y="2562120"/>
              <a:ext cx="1096920" cy="382680"/>
              <a:chOff x="479520" y="2562120"/>
              <a:chExt cx="1096920" cy="382680"/>
            </a:xfrm>
          </p:grpSpPr>
          <p:sp>
            <p:nvSpPr>
              <p:cNvPr id="178" name=""/>
              <p:cNvSpPr/>
              <p:nvPr/>
            </p:nvSpPr>
            <p:spPr>
              <a:xfrm>
                <a:off x="479520" y="2562120"/>
                <a:ext cx="1096920" cy="304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688320" y="2576520"/>
                <a:ext cx="6786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LEU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0" name=""/>
            <p:cNvGrpSpPr/>
            <p:nvPr/>
          </p:nvGrpSpPr>
          <p:grpSpPr>
            <a:xfrm>
              <a:off x="7742160" y="2571840"/>
              <a:ext cx="1096920" cy="382680"/>
              <a:chOff x="7742160" y="2571840"/>
              <a:chExt cx="1096920" cy="382680"/>
            </a:xfrm>
          </p:grpSpPr>
          <p:sp>
            <p:nvSpPr>
              <p:cNvPr id="181" name=""/>
              <p:cNvSpPr/>
              <p:nvPr/>
            </p:nvSpPr>
            <p:spPr>
              <a:xfrm>
                <a:off x="7742160" y="2571840"/>
                <a:ext cx="1096920" cy="3049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7950960" y="2586240"/>
                <a:ext cx="6786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GLU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3" name=""/>
            <p:cNvSpPr/>
            <p:nvPr/>
          </p:nvSpPr>
          <p:spPr>
            <a:xfrm>
              <a:off x="6086520" y="2535120"/>
              <a:ext cx="0" cy="3351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4" name=""/>
          <p:cNvGrpSpPr/>
          <p:nvPr/>
        </p:nvGrpSpPr>
        <p:grpSpPr>
          <a:xfrm>
            <a:off x="7975440" y="2208240"/>
            <a:ext cx="1257480" cy="307080"/>
            <a:chOff x="7975440" y="2208240"/>
            <a:chExt cx="1257480" cy="307080"/>
          </a:xfrm>
        </p:grpSpPr>
        <p:sp>
          <p:nvSpPr>
            <p:cNvPr id="185" name=""/>
            <p:cNvSpPr/>
            <p:nvPr/>
          </p:nvSpPr>
          <p:spPr>
            <a:xfrm>
              <a:off x="8319960" y="2208240"/>
              <a:ext cx="912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Cat.Glu.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 flipH="1">
              <a:off x="7975440" y="2360520"/>
              <a:ext cx="384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7" name=""/>
          <p:cNvGrpSpPr/>
          <p:nvPr/>
        </p:nvGrpSpPr>
        <p:grpSpPr>
          <a:xfrm>
            <a:off x="334800" y="2201760"/>
            <a:ext cx="1193760" cy="307080"/>
            <a:chOff x="334800" y="2201760"/>
            <a:chExt cx="1193760" cy="307080"/>
          </a:xfrm>
        </p:grpSpPr>
        <p:sp>
          <p:nvSpPr>
            <p:cNvPr id="188" name=""/>
            <p:cNvSpPr/>
            <p:nvPr/>
          </p:nvSpPr>
          <p:spPr>
            <a:xfrm>
              <a:off x="995040" y="2354040"/>
              <a:ext cx="533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334800" y="2201760"/>
              <a:ext cx="863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Leu.1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0" name=""/>
          <p:cNvGrpSpPr/>
          <p:nvPr/>
        </p:nvGrpSpPr>
        <p:grpSpPr>
          <a:xfrm>
            <a:off x="4562640" y="2259000"/>
            <a:ext cx="1193760" cy="307080"/>
            <a:chOff x="4562640" y="2259000"/>
            <a:chExt cx="1193760" cy="307080"/>
          </a:xfrm>
        </p:grpSpPr>
        <p:sp>
          <p:nvSpPr>
            <p:cNvPr id="191" name=""/>
            <p:cNvSpPr/>
            <p:nvPr/>
          </p:nvSpPr>
          <p:spPr>
            <a:xfrm>
              <a:off x="5222880" y="2411280"/>
              <a:ext cx="533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4562640" y="2259000"/>
              <a:ext cx="863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5.1522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3" name=""/>
          <p:cNvGrpSpPr/>
          <p:nvPr/>
        </p:nvGrpSpPr>
        <p:grpSpPr>
          <a:xfrm>
            <a:off x="3314520" y="2268360"/>
            <a:ext cx="1333800" cy="307080"/>
            <a:chOff x="3314520" y="2268360"/>
            <a:chExt cx="1333800" cy="307080"/>
          </a:xfrm>
        </p:grpSpPr>
        <p:sp>
          <p:nvSpPr>
            <p:cNvPr id="194" name=""/>
            <p:cNvSpPr/>
            <p:nvPr/>
          </p:nvSpPr>
          <p:spPr>
            <a:xfrm>
              <a:off x="3784680" y="226836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5.907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 flipH="1">
              <a:off x="3314520" y="2420640"/>
              <a:ext cx="507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6" name=""/>
          <p:cNvGrpSpPr/>
          <p:nvPr/>
        </p:nvGrpSpPr>
        <p:grpSpPr>
          <a:xfrm>
            <a:off x="2048040" y="1924200"/>
            <a:ext cx="1193760" cy="307080"/>
            <a:chOff x="2048040" y="1924200"/>
            <a:chExt cx="1193760" cy="307080"/>
          </a:xfrm>
        </p:grpSpPr>
        <p:sp>
          <p:nvSpPr>
            <p:cNvPr id="197" name=""/>
            <p:cNvSpPr/>
            <p:nvPr/>
          </p:nvSpPr>
          <p:spPr>
            <a:xfrm>
              <a:off x="2708280" y="2076480"/>
              <a:ext cx="533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2048040" y="1924200"/>
              <a:ext cx="863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5.739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9" name=""/>
          <p:cNvGrpSpPr/>
          <p:nvPr/>
        </p:nvGrpSpPr>
        <p:grpSpPr>
          <a:xfrm>
            <a:off x="5762160" y="1943280"/>
            <a:ext cx="1333800" cy="307080"/>
            <a:chOff x="5762160" y="1943280"/>
            <a:chExt cx="1333800" cy="307080"/>
          </a:xfrm>
        </p:grpSpPr>
        <p:sp>
          <p:nvSpPr>
            <p:cNvPr id="200" name=""/>
            <p:cNvSpPr/>
            <p:nvPr/>
          </p:nvSpPr>
          <p:spPr>
            <a:xfrm>
              <a:off x="6232320" y="194328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5.1636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 flipH="1">
              <a:off x="5762160" y="2095560"/>
              <a:ext cx="507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2" name=""/>
          <p:cNvSpPr/>
          <p:nvPr/>
        </p:nvSpPr>
        <p:spPr>
          <a:xfrm>
            <a:off x="8204040" y="3110040"/>
            <a:ext cx="110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Cato.1599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flipH="1">
            <a:off x="7810200" y="326232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lg" type="triangle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4" name=""/>
          <p:cNvGrpSpPr/>
          <p:nvPr/>
        </p:nvGrpSpPr>
        <p:grpSpPr>
          <a:xfrm>
            <a:off x="334800" y="3103560"/>
            <a:ext cx="1193760" cy="307080"/>
            <a:chOff x="334800" y="3103560"/>
            <a:chExt cx="1193760" cy="307080"/>
          </a:xfrm>
        </p:grpSpPr>
        <p:sp>
          <p:nvSpPr>
            <p:cNvPr id="205" name=""/>
            <p:cNvSpPr/>
            <p:nvPr/>
          </p:nvSpPr>
          <p:spPr>
            <a:xfrm>
              <a:off x="995040" y="3255840"/>
              <a:ext cx="533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334800" y="3103560"/>
              <a:ext cx="863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Glu3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7" name=""/>
          <p:cNvGrpSpPr/>
          <p:nvPr/>
        </p:nvGrpSpPr>
        <p:grpSpPr>
          <a:xfrm>
            <a:off x="6702120" y="3086280"/>
            <a:ext cx="1104840" cy="307080"/>
            <a:chOff x="6702120" y="3086280"/>
            <a:chExt cx="1104840" cy="307080"/>
          </a:xfrm>
        </p:grpSpPr>
        <p:sp>
          <p:nvSpPr>
            <p:cNvPr id="208" name=""/>
            <p:cNvSpPr/>
            <p:nvPr/>
          </p:nvSpPr>
          <p:spPr>
            <a:xfrm>
              <a:off x="7091640" y="3086280"/>
              <a:ext cx="715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Thr.5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 flipH="1">
              <a:off x="6702120" y="3238560"/>
              <a:ext cx="420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0" name=""/>
          <p:cNvSpPr/>
          <p:nvPr/>
        </p:nvSpPr>
        <p:spPr>
          <a:xfrm>
            <a:off x="3552840" y="3619440"/>
            <a:ext cx="1192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Cyt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1141 b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1" name=""/>
          <p:cNvGrpSpPr/>
          <p:nvPr/>
        </p:nvGrpSpPr>
        <p:grpSpPr>
          <a:xfrm>
            <a:off x="2557440" y="3135240"/>
            <a:ext cx="1307880" cy="307080"/>
            <a:chOff x="2557440" y="3135240"/>
            <a:chExt cx="1307880" cy="307080"/>
          </a:xfrm>
        </p:grpSpPr>
        <p:sp>
          <p:nvSpPr>
            <p:cNvPr id="212" name=""/>
            <p:cNvSpPr/>
            <p:nvPr/>
          </p:nvSpPr>
          <p:spPr>
            <a:xfrm>
              <a:off x="3369960" y="3287520"/>
              <a:ext cx="495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2557440" y="3135240"/>
              <a:ext cx="94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Pan.494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4" name=""/>
          <p:cNvGrpSpPr/>
          <p:nvPr/>
        </p:nvGrpSpPr>
        <p:grpSpPr>
          <a:xfrm>
            <a:off x="4309560" y="3139920"/>
            <a:ext cx="1676520" cy="307080"/>
            <a:chOff x="4309560" y="3139920"/>
            <a:chExt cx="1676520" cy="307080"/>
          </a:xfrm>
        </p:grpSpPr>
        <p:sp>
          <p:nvSpPr>
            <p:cNvPr id="215" name=""/>
            <p:cNvSpPr/>
            <p:nvPr/>
          </p:nvSpPr>
          <p:spPr>
            <a:xfrm>
              <a:off x="4900320" y="3139920"/>
              <a:ext cx="1085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Pan.636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 flipH="1">
              <a:off x="4309560" y="3292200"/>
              <a:ext cx="638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7" name=""/>
          <p:cNvGrpSpPr/>
          <p:nvPr/>
        </p:nvGrpSpPr>
        <p:grpSpPr>
          <a:xfrm>
            <a:off x="7810200" y="1928880"/>
            <a:ext cx="1486080" cy="307080"/>
            <a:chOff x="7810200" y="1928880"/>
            <a:chExt cx="1486080" cy="307080"/>
          </a:xfrm>
        </p:grpSpPr>
        <p:sp>
          <p:nvSpPr>
            <p:cNvPr id="218" name=""/>
            <p:cNvSpPr/>
            <p:nvPr/>
          </p:nvSpPr>
          <p:spPr>
            <a:xfrm>
              <a:off x="8120160" y="1928880"/>
              <a:ext cx="1176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Cato.Glu.2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flipH="1">
              <a:off x="7810200" y="2081160"/>
              <a:ext cx="361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0" name=""/>
          <p:cNvGrpSpPr/>
          <p:nvPr/>
        </p:nvGrpSpPr>
        <p:grpSpPr>
          <a:xfrm>
            <a:off x="-76320" y="647640"/>
            <a:ext cx="1422360" cy="307080"/>
            <a:chOff x="-76320" y="647640"/>
            <a:chExt cx="1422360" cy="307080"/>
          </a:xfrm>
        </p:grpSpPr>
        <p:sp>
          <p:nvSpPr>
            <p:cNvPr id="221" name=""/>
            <p:cNvSpPr/>
            <p:nvPr/>
          </p:nvSpPr>
          <p:spPr>
            <a:xfrm>
              <a:off x="919080" y="800280"/>
              <a:ext cx="42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lg" type="triangle" w="lg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-76320" y="647640"/>
              <a:ext cx="1185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Cato.Arg.1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"/>
          <p:cNvSpPr/>
          <p:nvPr/>
        </p:nvSpPr>
        <p:spPr>
          <a:xfrm>
            <a:off x="0" y="0"/>
            <a:ext cx="9144000" cy="64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xternal Prime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o.Arg.1F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AGTCCAAAACAAGACCCTTGATTTC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.Glu.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TTCTTATAGTTGAATAACAACGGTG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o.15990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GTTTAGTTTTAGAATCCTGGCTTTG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nternal Prime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o.Arg.2F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AGACCTCTGATTTCGGCT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o.ND4.369F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AAGCCACTCTAATTCCAACCT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o.ND4.598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TACGAGGAAGGCAATTAAG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o.His.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CAATCTAGTGTTTTAAGTTAAA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EU.1F  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TCTTAGGAACCAAAAACTCTT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.ND5.739F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CCCTACTCCACTCAAGCA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o.ND5.907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TGGATGTAGAGAAGGCTACA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o.ND5.1522F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CCCTAACTAACAAGCAATT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o.ND5.1636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GACAAACAATCGCCACC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ato.GLU.2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AGTTGAATAACAACGGTGGTT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lu3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GRCTTGAAAAACCACCGTTG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an.Thr.5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CTCTAGGGAGGAGTTTAAC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Optional Internal cyt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Prime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an.494F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AGGTGGATTTTCAGTAGATAATG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an.636R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AGAGATTTTGTCCGCATCCG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5T20:41:11Z</dcterms:created>
  <dc:creator>Peter Unmack</dc:creator>
  <dc:description/>
  <dc:language>en-US</dc:language>
  <cp:lastModifiedBy>Peter J Unmack</cp:lastModifiedBy>
  <dcterms:modified xsi:type="dcterms:W3CDTF">2013-06-30T11:54:16Z</dcterms:modified>
  <cp:revision>22</cp:revision>
  <dc:subject/>
  <dc:title>Slide 1</dc:title>
</cp:coreProperties>
</file>